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1E46D-9829-4A8C-A467-08415A0047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307F3F-BD83-4DE3-8B9D-34D47A12DD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89634-A48E-45CD-B12B-F65D0B7BB1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17860-C7B7-4578-893E-F1BBBFD667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56AEBB-D695-4FDD-AAFB-2A7980B9DA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BACF2B-7D4C-4EA6-8393-972229F689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6C9342-5C5A-43F5-A148-DF410488FD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050570-BB43-4A0D-81F1-3DC8F9F856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431A6-A86B-48EE-87DB-38103F14EC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A53BD8-5961-4F7B-A3B3-93DEA8F116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D5CB95-E1CB-43DD-BAC6-CE97D22927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03226E-277C-4010-8E83-638D68F16E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74392A-EC86-4D60-BE95-53E78B69A87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itle 1"/>
          <p:cNvSpPr/>
          <p:nvPr/>
        </p:nvSpPr>
        <p:spPr>
          <a:xfrm>
            <a:off x="609480" y="1371600"/>
            <a:ext cx="8001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3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op network associated functions generated using  1.5-fold up-regulated genes</a:t>
            </a: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531800" y="1874880"/>
          <a:ext cx="6080400" cy="3108240"/>
        </p:xfrm>
        <a:graphic>
          <a:graphicData uri="http://schemas.openxmlformats.org/drawingml/2006/table">
            <a:tbl>
              <a:tblPr/>
              <a:tblGrid>
                <a:gridCol w="468360"/>
                <a:gridCol w="2457720"/>
                <a:gridCol w="514080"/>
                <a:gridCol w="2114640"/>
                <a:gridCol w="525600"/>
              </a:tblGrid>
              <a:tr h="36504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/w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T474 associated network func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cor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KBR3 associated network func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cor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3188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ellular Movement, Cancer, Cellular Growth and Prolifer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ellular Growth and Proliferation, Cellular Movement, Cellular Developme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684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ancer, Cell Cycle, Cellular Growth and Prolifer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ell Death, Cancer, Cell-To-Cell Signaling and Interac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504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ancer, Cell Death, Molecular Transpor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ancer, Tumor Morphology, Hematological Disea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4936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ancer, Gene Expression, Cellular Growth and Prolifer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ell Death, Inflammatory Disease, Skeletal and Muscular Disorde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3008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ell-To-Cell Signaling and Interaction, Hematological System Development and Function, Immune Cell Traffick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ell Cycle, Cell Death, Canc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19T17:32:31Z</dcterms:created>
  <dc:creator>ykulkarni</dc:creator>
  <dc:description/>
  <dc:language>en-US</dc:language>
  <cp:lastModifiedBy>David Klinke</cp:lastModifiedBy>
  <dcterms:modified xsi:type="dcterms:W3CDTF">2010-06-11T21:33:13Z</dcterms:modified>
  <cp:revision>5</cp:revision>
  <dc:subject/>
  <dc:title>Slide 1</dc:title>
</cp:coreProperties>
</file>